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wmf" ContentType="image/x-wmf"/>
  <Override PartName="/ppt/media/image4.png" ContentType="image/png"/>
  <Override PartName="/ppt/media/image5.jpeg" ContentType="image/jpe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5726A-D8B0-4975-A945-A48E7DA8F2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8ECCAB-53F5-42AF-908B-059ADE69DF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7589C2-19B5-4A6F-B846-D45C637BA7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082AA-2A32-41D4-8077-78C1A31469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D5FE0-546F-4AD2-B741-5398156FE3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FAF36-5E74-427B-A76F-C220C235F8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9BDEA-B2D6-4BCA-882F-DEA3505243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6A7573-23C7-4A64-85F1-7424463712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A0952D-D43F-4E5A-89F6-83EF2A16A7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89A84-1382-4913-BA31-51DD98CF67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53DAA-071C-462C-BE37-EB52DED21C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B9758-C75D-4AB0-A378-3F3670A989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D46F7B-7E2C-4DA7-BDEC-D767AB2B9A11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oleObject" Target="../embeddings/oleObject1.bin"/><Relationship Id="rId3" Type="http://schemas.openxmlformats.org/officeDocument/2006/relationships/image" Target="../media/image4.png"/><Relationship Id="rId4" Type="http://schemas.openxmlformats.org/officeDocument/2006/relationships/image" Target="../media/image5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6"/>
          <p:cNvSpPr/>
          <p:nvPr/>
        </p:nvSpPr>
        <p:spPr>
          <a:xfrm>
            <a:off x="250920" y="115920"/>
            <a:ext cx="5616360" cy="51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Calibri"/>
              </a:rPr>
              <a:t>Table S1. Primer sequence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100" spc="-1" strike="noStrike">
                <a:solidFill>
                  <a:srgbClr val="000000"/>
                </a:solidFill>
                <a:latin typeface="Calibri"/>
              </a:rPr>
              <a:t>For </a:t>
            </a:r>
            <a:r>
              <a:rPr b="0" i="1" lang="de-DE" sz="1100" spc="-1" strike="noStrike">
                <a:solidFill>
                  <a:srgbClr val="000000"/>
                </a:solidFill>
                <a:latin typeface="Calibri"/>
              </a:rPr>
              <a:t>PITX2</a:t>
            </a:r>
            <a:r>
              <a:rPr b="0" lang="de-DE" sz="1100" spc="-1" strike="noStrike">
                <a:solidFill>
                  <a:srgbClr val="000000"/>
                </a:solidFill>
                <a:latin typeface="Calibri"/>
              </a:rPr>
              <a:t> and </a:t>
            </a:r>
            <a:r>
              <a:rPr b="0" i="1" lang="de-DE" sz="1100" spc="-1" strike="noStrike">
                <a:solidFill>
                  <a:srgbClr val="000000"/>
                </a:solidFill>
                <a:latin typeface="Calibri"/>
              </a:rPr>
              <a:t>MYC</a:t>
            </a:r>
            <a:r>
              <a:rPr b="0" lang="de-DE" sz="1100" spc="-1" strike="noStrike">
                <a:solidFill>
                  <a:srgbClr val="000000"/>
                </a:solidFill>
                <a:latin typeface="Calibri"/>
              </a:rPr>
              <a:t>, please see materials and methods section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Bild 1" descr=""/>
          <p:cNvPicPr/>
          <p:nvPr/>
        </p:nvPicPr>
        <p:blipFill>
          <a:blip r:embed="rId1"/>
          <a:stretch/>
        </p:blipFill>
        <p:spPr>
          <a:xfrm>
            <a:off x="324000" y="966960"/>
            <a:ext cx="8640720" cy="1814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uppierung 2"/>
          <p:cNvGrpSpPr/>
          <p:nvPr/>
        </p:nvGrpSpPr>
        <p:grpSpPr>
          <a:xfrm>
            <a:off x="324000" y="971640"/>
            <a:ext cx="6480000" cy="4701960"/>
            <a:chOff x="324000" y="971640"/>
            <a:chExt cx="6480000" cy="4701960"/>
          </a:xfrm>
        </p:grpSpPr>
        <p:grpSp>
          <p:nvGrpSpPr>
            <p:cNvPr id="44" name="Group 10"/>
            <p:cNvGrpSpPr/>
            <p:nvPr/>
          </p:nvGrpSpPr>
          <p:grpSpPr>
            <a:xfrm>
              <a:off x="324000" y="971640"/>
              <a:ext cx="4464000" cy="4701960"/>
              <a:chOff x="324000" y="971640"/>
              <a:chExt cx="4464000" cy="4701960"/>
            </a:xfrm>
          </p:grpSpPr>
          <p:pic>
            <p:nvPicPr>
              <p:cNvPr id="45" name="Picture 8" descr=""/>
              <p:cNvPicPr/>
              <p:nvPr/>
            </p:nvPicPr>
            <p:blipFill>
              <a:blip r:embed="rId1"/>
              <a:srcRect l="14044" t="7313" r="7859" b="37643"/>
              <a:stretch/>
            </p:blipFill>
            <p:spPr>
              <a:xfrm>
                <a:off x="951120" y="971640"/>
                <a:ext cx="3485880" cy="3178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9" descr=""/>
              <p:cNvPicPr/>
              <p:nvPr/>
            </p:nvPicPr>
            <p:blipFill>
              <a:blip r:embed="rId2"/>
              <a:srcRect l="0" t="76082" r="0" b="0"/>
              <a:stretch/>
            </p:blipFill>
            <p:spPr>
              <a:xfrm>
                <a:off x="324000" y="4292640"/>
                <a:ext cx="4464000" cy="13809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47" name="Text Box 7"/>
            <p:cNvSpPr/>
            <p:nvPr/>
          </p:nvSpPr>
          <p:spPr>
            <a:xfrm>
              <a:off x="946080" y="5300640"/>
              <a:ext cx="5857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8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Figure S1. </a:t>
              </a:r>
              <a:r>
                <a:rPr b="1" lang="en-US" sz="11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pCL6IEGwo plasmid used for lentiviral overexpression experiments. 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uppierung 2"/>
          <p:cNvGrpSpPr/>
          <p:nvPr/>
        </p:nvGrpSpPr>
        <p:grpSpPr>
          <a:xfrm>
            <a:off x="3049560" y="561960"/>
            <a:ext cx="2784600" cy="1879560"/>
            <a:chOff x="3049560" y="561960"/>
            <a:chExt cx="2784600" cy="1879560"/>
          </a:xfrm>
        </p:grpSpPr>
        <p:pic>
          <p:nvPicPr>
            <p:cNvPr id="49" name="Picture 28" descr="PCL6OSX"/>
            <p:cNvPicPr/>
            <p:nvPr/>
          </p:nvPicPr>
          <p:blipFill>
            <a:blip r:embed="rId1"/>
            <a:srcRect l="4595" t="0" r="2707" b="0"/>
            <a:stretch/>
          </p:blipFill>
          <p:spPr>
            <a:xfrm>
              <a:off x="3049560" y="561960"/>
              <a:ext cx="2784600" cy="1879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 Box 43"/>
            <p:cNvSpPr/>
            <p:nvPr/>
          </p:nvSpPr>
          <p:spPr>
            <a:xfrm>
              <a:off x="4251240" y="1434960"/>
              <a:ext cx="647640" cy="337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PCL6OSX 10287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51" name="Object 34"/>
          <p:cNvGraphicFramePr/>
          <p:nvPr/>
        </p:nvGraphicFramePr>
        <p:xfrm>
          <a:off x="5575320" y="460440"/>
          <a:ext cx="3562200" cy="250668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52" name="Object 34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5575320" y="460440"/>
                    <a:ext cx="3562200" cy="2506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Text Box 35"/>
          <p:cNvSpPr/>
          <p:nvPr/>
        </p:nvSpPr>
        <p:spPr>
          <a:xfrm>
            <a:off x="6918480" y="1498680"/>
            <a:ext cx="1079280" cy="36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6"/>
          <p:cNvSpPr/>
          <p:nvPr/>
        </p:nvSpPr>
        <p:spPr>
          <a:xfrm>
            <a:off x="7016760" y="1436760"/>
            <a:ext cx="93492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Calibri"/>
              </a:rPr>
              <a:t>PCL6BMP4                      10223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39"/>
          <p:cNvSpPr/>
          <p:nvPr/>
        </p:nvSpPr>
        <p:spPr>
          <a:xfrm>
            <a:off x="115920" y="2924280"/>
            <a:ext cx="5680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Calibri"/>
              </a:rPr>
              <a:t>Figure S2. PCL6IEGwo including the inserted genes (BSP, OSX and BMP4)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26"/>
          <p:cNvSpPr/>
          <p:nvPr/>
        </p:nvSpPr>
        <p:spPr>
          <a:xfrm>
            <a:off x="-198360" y="26431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27"/>
          <p:cNvSpPr/>
          <p:nvPr/>
        </p:nvSpPr>
        <p:spPr>
          <a:xfrm>
            <a:off x="0" y="292572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Gruppierung 1"/>
          <p:cNvGrpSpPr/>
          <p:nvPr/>
        </p:nvGrpSpPr>
        <p:grpSpPr>
          <a:xfrm>
            <a:off x="68400" y="561960"/>
            <a:ext cx="3019320" cy="1898640"/>
            <a:chOff x="68400" y="561960"/>
            <a:chExt cx="3019320" cy="1898640"/>
          </a:xfrm>
        </p:grpSpPr>
        <p:pic>
          <p:nvPicPr>
            <p:cNvPr id="59" name="Picture 30" descr="BSP in PCL6"/>
            <p:cNvPicPr/>
            <p:nvPr/>
          </p:nvPicPr>
          <p:blipFill>
            <a:blip r:embed="rId4"/>
            <a:srcRect l="3412" t="1784" r="6875" b="78596"/>
            <a:stretch/>
          </p:blipFill>
          <p:spPr>
            <a:xfrm>
              <a:off x="68400" y="561960"/>
              <a:ext cx="3019320" cy="1898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" name="Text Box 31"/>
            <p:cNvSpPr/>
            <p:nvPr/>
          </p:nvSpPr>
          <p:spPr>
            <a:xfrm>
              <a:off x="1506600" y="1434960"/>
              <a:ext cx="647640" cy="337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Calibri"/>
                </a:rPr>
                <a:t>PCL6BSP   9945 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9T12:30:23Z</dcterms:created>
  <dc:creator>bosch</dc:creator>
  <dc:description/>
  <dc:language>en-US</dc:language>
  <cp:lastModifiedBy>Julia Bosch</cp:lastModifiedBy>
  <dcterms:modified xsi:type="dcterms:W3CDTF">2013-03-05T07:54:46Z</dcterms:modified>
  <cp:revision>29</cp:revision>
  <dc:subject/>
  <dc:title>Folie 1</dc:title>
</cp:coreProperties>
</file>